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>
        <p:scale>
          <a:sx n="135" d="100"/>
          <a:sy n="135" d="100"/>
        </p:scale>
        <p:origin x="216" y="-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7DC257-D218-32D7-0D12-91FC794C42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E8CB38-502D-6D16-406D-47143BED22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7A934C-60AD-9CB2-4D37-DEF75ED2FF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4BAB04-356A-E26D-14A2-0CC83DF76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4DECF5-964B-F45D-61A1-2ED6F4A49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761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DF32E2-B6F6-E116-7013-C0C9570406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67C91B-1EDE-6C08-B88E-EC11587A40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AB83AB-AA8C-31F0-3AF7-722CDEB3F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637A8A-DD63-CDF4-EB96-84582A08C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C81F9D-7FFC-4F19-EDE6-1C57A4AC9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733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72B2AB-7C7A-C022-5F38-8145D4FEFF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408B2B-54EF-315D-4FA2-8504E46117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01CF59-8058-DD46-1AD8-ADF17B631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30B7EE-3530-6EC6-BF5C-99290DDE0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62FD14-7A14-E154-090E-3CB83C7EC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083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D9F28A-6A62-EACF-D6B0-4AB66FB2A0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396541-4A3B-F642-A9F4-A214318976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BA0B47-74F2-3B7A-AFFA-CAF117D6D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1DF6A9-55D1-2E6D-924C-C23A011DF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C5C297-0394-CAC1-CD9F-347E0C09F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26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C0EC5A-1C6A-0534-8CF2-2034B64515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C7800C-1275-4963-1A77-A988C2A60D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5A38A6-5418-9862-65A9-93A10742B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C6FBEC-93B4-A17D-F4B0-474B395D6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077F99-5519-57DC-2BD4-2345BEDDC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048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ADB50D-464E-BB93-79A2-A910F76FDC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83B5B-0AAF-167E-84F8-83AC70583B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58D5D9-75E7-0015-898A-45A77B6F26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1240C7-7B59-433D-89E6-A6DE9DC504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1C7D24-9B0D-6B77-6A08-00AABB6CB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B67C97-85D5-9ED2-B136-A06063A73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195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D89348-B6EA-4414-B94B-77C7661405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02D149-642A-6048-C5CF-E20EA96CCC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E17A78-C028-DC1D-B952-39D7C9F988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5C58F6-8CB8-B68D-C5AD-4E06C20581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158392-EFE3-1E41-B227-0FF38D16A8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FDCD33-C968-D43B-CEA4-3A18DA69C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F917B9-5529-C52D-B8DF-E3B7E1686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F4DF93-A507-9A58-72D0-BE2DFB34E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77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446ED-F6CF-1B70-0705-BA09424F26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D7D476-297D-87AC-EB0A-4869E3F71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FAE109-0F09-9505-EBC1-DAA8DD47D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45E71E-25CD-398A-0B1F-3DE1DD7CA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52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B514635-7E0A-FB4C-6230-9892C9C70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465D70-986B-C023-E806-254F8A511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ECEF79-437E-6302-2A95-CBEDFC109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785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E3A556-DD96-3EBC-DDA7-5F6CED15F5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CB5550-2ED1-0FD1-7F7D-0586A6B43C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0A72D6-CA46-B31E-E36E-D52C802950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948210-29FD-F46D-212A-5DEE47CCD3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A46C4F-A08D-E502-F850-D9D142B74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A79F43-CBDC-DE13-E66F-1C3931FC1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277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5A9E8-2B9E-8057-A9D9-A51F9409B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DA4581-DB36-BB25-C889-F80802BEDB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0BEBCB-D2AE-BF45-026B-D94BCF0497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BE8F1C-E62A-F5C7-25C1-F485A4C75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EF3AA9-947D-391D-3C8F-C0DE3C647C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9FFCD5-1CF6-8D8D-1094-029DDB7A2E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88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A5D032-89D1-62DA-831D-EE8EFC77DF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E387EB-1420-C1CD-630B-F8814CC712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7D4A6E-8DC4-CDA9-5D39-752B9EEFA3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BA365A0-96DC-864B-BB65-2E858297008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602080-EA6A-F5E8-75E6-361756EEC7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5C4CE0-8721-05B3-0290-9DF4B04ADB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87495B-4C68-B640-8ED2-03F677EA8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171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picture containing black and white, monochrome, white, black&#10;&#10;Description automatically generated">
            <a:extLst>
              <a:ext uri="{FF2B5EF4-FFF2-40B4-BE49-F238E27FC236}">
                <a16:creationId xmlns:a16="http://schemas.microsoft.com/office/drawing/2014/main" id="{243E1937-5B7C-1ABB-D0C9-C099DEABEF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23093" y="3750651"/>
            <a:ext cx="3232000" cy="2498096"/>
          </a:xfrm>
          <a:prstGeom prst="rect">
            <a:avLst/>
          </a:prstGeom>
        </p:spPr>
      </p:pic>
      <p:pic>
        <p:nvPicPr>
          <p:cNvPr id="10" name="Picture 9" descr="A picture containing sketch, black and white, monochrome, black&#10;&#10;Description automatically generated">
            <a:extLst>
              <a:ext uri="{FF2B5EF4-FFF2-40B4-BE49-F238E27FC236}">
                <a16:creationId xmlns:a16="http://schemas.microsoft.com/office/drawing/2014/main" id="{E38BB6FD-85C0-EF50-270E-61C03AB877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62521" y="1180384"/>
            <a:ext cx="3232001" cy="2498097"/>
          </a:xfrm>
          <a:prstGeom prst="rect">
            <a:avLst/>
          </a:prstGeom>
        </p:spPr>
      </p:pic>
      <p:pic>
        <p:nvPicPr>
          <p:cNvPr id="9" name="Picture 8" descr="A close-up of a building&#10;&#10;Description automatically generated with low confidence">
            <a:extLst>
              <a:ext uri="{FF2B5EF4-FFF2-40B4-BE49-F238E27FC236}">
                <a16:creationId xmlns:a16="http://schemas.microsoft.com/office/drawing/2014/main" id="{D50FD4D9-41F8-2ED8-18C7-CEF329B3B2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52741" y="3750651"/>
            <a:ext cx="3232001" cy="2498097"/>
          </a:xfrm>
          <a:prstGeom prst="rect">
            <a:avLst/>
          </a:prstGeom>
        </p:spPr>
      </p:pic>
      <p:pic>
        <p:nvPicPr>
          <p:cNvPr id="2" name="Picture 1" descr="A close-up of a paper&#10;&#10;Description automatically generated with low confidence">
            <a:extLst>
              <a:ext uri="{FF2B5EF4-FFF2-40B4-BE49-F238E27FC236}">
                <a16:creationId xmlns:a16="http://schemas.microsoft.com/office/drawing/2014/main" id="{9C55F8EB-1BE4-F1A3-051D-BABD88ECFA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55077" y="1180384"/>
            <a:ext cx="3232002" cy="2498098"/>
          </a:xfrm>
          <a:prstGeom prst="rect">
            <a:avLst/>
          </a:prstGeom>
        </p:spPr>
      </p:pic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B6D9435D-D84E-512F-A9FE-4097E6DB7E44}"/>
              </a:ext>
            </a:extLst>
          </p:cNvPr>
          <p:cNvCxnSpPr>
            <a:cxnSpLocks/>
          </p:cNvCxnSpPr>
          <p:nvPr/>
        </p:nvCxnSpPr>
        <p:spPr>
          <a:xfrm>
            <a:off x="4909356" y="3137115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E34E629D-3447-F24E-B14E-AE4C4043C03F}"/>
              </a:ext>
            </a:extLst>
          </p:cNvPr>
          <p:cNvSpPr txBox="1"/>
          <p:nvPr/>
        </p:nvSpPr>
        <p:spPr>
          <a:xfrm>
            <a:off x="5004677" y="3021716"/>
            <a:ext cx="803665" cy="230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F7CE6B4C-DDF6-2977-93E9-465EF4ACC372}"/>
              </a:ext>
            </a:extLst>
          </p:cNvPr>
          <p:cNvCxnSpPr>
            <a:cxnSpLocks/>
          </p:cNvCxnSpPr>
          <p:nvPr/>
        </p:nvCxnSpPr>
        <p:spPr>
          <a:xfrm>
            <a:off x="4909356" y="5024634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3F39434C-FBBA-0F8B-06C7-EA48F74A0584}"/>
              </a:ext>
            </a:extLst>
          </p:cNvPr>
          <p:cNvSpPr txBox="1"/>
          <p:nvPr/>
        </p:nvSpPr>
        <p:spPr>
          <a:xfrm>
            <a:off x="5004677" y="4909224"/>
            <a:ext cx="803665" cy="2308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3A15082-E39D-F62C-8163-0EAD5117DEEF}"/>
              </a:ext>
            </a:extLst>
          </p:cNvPr>
          <p:cNvSpPr txBox="1"/>
          <p:nvPr/>
        </p:nvSpPr>
        <p:spPr>
          <a:xfrm>
            <a:off x="2874422" y="162996"/>
            <a:ext cx="8036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el #1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48B6C2E4-6E60-E64E-452F-66A5761D04A2}"/>
              </a:ext>
            </a:extLst>
          </p:cNvPr>
          <p:cNvCxnSpPr>
            <a:cxnSpLocks/>
          </p:cNvCxnSpPr>
          <p:nvPr/>
        </p:nvCxnSpPr>
        <p:spPr>
          <a:xfrm>
            <a:off x="1398027" y="3176113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FD3178C0-7F99-206E-C134-6A6C914A5F5E}"/>
              </a:ext>
            </a:extLst>
          </p:cNvPr>
          <p:cNvSpPr txBox="1"/>
          <p:nvPr/>
        </p:nvSpPr>
        <p:spPr>
          <a:xfrm>
            <a:off x="624382" y="3059029"/>
            <a:ext cx="803665" cy="230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kD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1BA36073-4F5C-CAB0-ACD6-418E422F92C4}"/>
              </a:ext>
            </a:extLst>
          </p:cNvPr>
          <p:cNvCxnSpPr>
            <a:cxnSpLocks/>
          </p:cNvCxnSpPr>
          <p:nvPr/>
        </p:nvCxnSpPr>
        <p:spPr>
          <a:xfrm>
            <a:off x="1398027" y="3353150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847F747A-6A45-462B-8976-6053AF226061}"/>
              </a:ext>
            </a:extLst>
          </p:cNvPr>
          <p:cNvSpPr txBox="1"/>
          <p:nvPr/>
        </p:nvSpPr>
        <p:spPr>
          <a:xfrm>
            <a:off x="624382" y="3236066"/>
            <a:ext cx="803665" cy="230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C7224AC-AE3B-7C92-DC6F-D54294DCB7B3}"/>
              </a:ext>
            </a:extLst>
          </p:cNvPr>
          <p:cNvCxnSpPr>
            <a:cxnSpLocks/>
          </p:cNvCxnSpPr>
          <p:nvPr/>
        </p:nvCxnSpPr>
        <p:spPr>
          <a:xfrm>
            <a:off x="1398027" y="5081344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0B004469-5A13-3DA7-0851-47DF158133AD}"/>
              </a:ext>
            </a:extLst>
          </p:cNvPr>
          <p:cNvSpPr txBox="1"/>
          <p:nvPr/>
        </p:nvSpPr>
        <p:spPr>
          <a:xfrm>
            <a:off x="624382" y="4964260"/>
            <a:ext cx="803665" cy="230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BD07537-B09E-0342-22B6-76D328872CCA}"/>
              </a:ext>
            </a:extLst>
          </p:cNvPr>
          <p:cNvCxnSpPr>
            <a:cxnSpLocks/>
          </p:cNvCxnSpPr>
          <p:nvPr/>
        </p:nvCxnSpPr>
        <p:spPr>
          <a:xfrm>
            <a:off x="1968705" y="902511"/>
            <a:ext cx="6149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DEC72AA9-661E-C989-94F4-D1C9D99C5D28}"/>
              </a:ext>
            </a:extLst>
          </p:cNvPr>
          <p:cNvSpPr txBox="1"/>
          <p:nvPr/>
        </p:nvSpPr>
        <p:spPr>
          <a:xfrm>
            <a:off x="1789294" y="652615"/>
            <a:ext cx="98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F liver cell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DD72B38-7D4F-6976-CD65-64367BFA16E6}"/>
              </a:ext>
            </a:extLst>
          </p:cNvPr>
          <p:cNvSpPr txBox="1"/>
          <p:nvPr/>
        </p:nvSpPr>
        <p:spPr>
          <a:xfrm>
            <a:off x="1775064" y="95064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9CC6BA4-AED0-D213-F7F1-7380A39FA9E4}"/>
              </a:ext>
            </a:extLst>
          </p:cNvPr>
          <p:cNvSpPr txBox="1"/>
          <p:nvPr/>
        </p:nvSpPr>
        <p:spPr>
          <a:xfrm>
            <a:off x="1981838" y="95064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FBE37AB-F34A-BDD0-7D2C-100D16581A8A}"/>
              </a:ext>
            </a:extLst>
          </p:cNvPr>
          <p:cNvSpPr txBox="1"/>
          <p:nvPr/>
        </p:nvSpPr>
        <p:spPr>
          <a:xfrm>
            <a:off x="2182003" y="95064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1D57C9A-BE23-0D67-CDC7-9F44EFDCF463}"/>
              </a:ext>
            </a:extLst>
          </p:cNvPr>
          <p:cNvSpPr txBox="1"/>
          <p:nvPr/>
        </p:nvSpPr>
        <p:spPr>
          <a:xfrm>
            <a:off x="2389983" y="95064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950FEC9-9586-8A79-D182-14B3A6026161}"/>
              </a:ext>
            </a:extLst>
          </p:cNvPr>
          <p:cNvSpPr txBox="1"/>
          <p:nvPr/>
        </p:nvSpPr>
        <p:spPr>
          <a:xfrm rot="18953798">
            <a:off x="4063325" y="539077"/>
            <a:ext cx="98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 liver cell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7E06D62-DEAD-0922-08E3-D333052117AC}"/>
              </a:ext>
            </a:extLst>
          </p:cNvPr>
          <p:cNvSpPr txBox="1"/>
          <p:nvPr/>
        </p:nvSpPr>
        <p:spPr>
          <a:xfrm>
            <a:off x="4195259" y="95035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8761E73A-ECFC-D2DC-2280-D608F558F45A}"/>
              </a:ext>
            </a:extLst>
          </p:cNvPr>
          <p:cNvCxnSpPr>
            <a:cxnSpLocks/>
          </p:cNvCxnSpPr>
          <p:nvPr/>
        </p:nvCxnSpPr>
        <p:spPr>
          <a:xfrm>
            <a:off x="2685737" y="901966"/>
            <a:ext cx="7005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1AB5D0A2-12D3-AC9A-1BF9-FD63D35F780F}"/>
              </a:ext>
            </a:extLst>
          </p:cNvPr>
          <p:cNvSpPr txBox="1"/>
          <p:nvPr/>
        </p:nvSpPr>
        <p:spPr>
          <a:xfrm>
            <a:off x="2543846" y="652615"/>
            <a:ext cx="98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 liver cells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23B9C23-23F3-FFAA-2590-9BA246C9BCEA}"/>
              </a:ext>
            </a:extLst>
          </p:cNvPr>
          <p:cNvSpPr txBox="1"/>
          <p:nvPr/>
        </p:nvSpPr>
        <p:spPr>
          <a:xfrm>
            <a:off x="2570783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8966E2C-F6DC-88C0-85C5-A09FFF609616}"/>
              </a:ext>
            </a:extLst>
          </p:cNvPr>
          <p:cNvSpPr txBox="1"/>
          <p:nvPr/>
        </p:nvSpPr>
        <p:spPr>
          <a:xfrm>
            <a:off x="2784647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2F1B3DF0-D08C-B9BE-2789-737473317B76}"/>
              </a:ext>
            </a:extLst>
          </p:cNvPr>
          <p:cNvSpPr txBox="1"/>
          <p:nvPr/>
        </p:nvSpPr>
        <p:spPr>
          <a:xfrm>
            <a:off x="2998987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86E8482-FD03-D97A-2AFB-D88C1A5A612E}"/>
              </a:ext>
            </a:extLst>
          </p:cNvPr>
          <p:cNvSpPr txBox="1"/>
          <p:nvPr/>
        </p:nvSpPr>
        <p:spPr>
          <a:xfrm>
            <a:off x="3206966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77F9A76D-6914-4E4E-AC53-EFE861477991}"/>
              </a:ext>
            </a:extLst>
          </p:cNvPr>
          <p:cNvCxnSpPr>
            <a:cxnSpLocks/>
          </p:cNvCxnSpPr>
          <p:nvPr/>
        </p:nvCxnSpPr>
        <p:spPr>
          <a:xfrm>
            <a:off x="3474334" y="901966"/>
            <a:ext cx="7005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970F6611-8E74-C18D-7A2D-A1A42EA20EBE}"/>
              </a:ext>
            </a:extLst>
          </p:cNvPr>
          <p:cNvSpPr txBox="1"/>
          <p:nvPr/>
        </p:nvSpPr>
        <p:spPr>
          <a:xfrm>
            <a:off x="3332443" y="652615"/>
            <a:ext cx="98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F liver cells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DE758B73-6514-7577-0B0E-41E21D929EA7}"/>
              </a:ext>
            </a:extLst>
          </p:cNvPr>
          <p:cNvSpPr txBox="1"/>
          <p:nvPr/>
        </p:nvSpPr>
        <p:spPr>
          <a:xfrm>
            <a:off x="3359380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BBC9A6F-DA96-3B56-3B52-C6A08482F5C4}"/>
              </a:ext>
            </a:extLst>
          </p:cNvPr>
          <p:cNvSpPr txBox="1"/>
          <p:nvPr/>
        </p:nvSpPr>
        <p:spPr>
          <a:xfrm>
            <a:off x="3573244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3E7A674C-299F-B865-763D-0367A5109718}"/>
              </a:ext>
            </a:extLst>
          </p:cNvPr>
          <p:cNvSpPr txBox="1"/>
          <p:nvPr/>
        </p:nvSpPr>
        <p:spPr>
          <a:xfrm>
            <a:off x="3787584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63AFC2A-91D0-1978-8745-B8AD27A22D75}"/>
              </a:ext>
            </a:extLst>
          </p:cNvPr>
          <p:cNvSpPr txBox="1"/>
          <p:nvPr/>
        </p:nvSpPr>
        <p:spPr>
          <a:xfrm>
            <a:off x="3995563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347C89DF-98F7-5969-E47D-FF6959966122}"/>
              </a:ext>
            </a:extLst>
          </p:cNvPr>
          <p:cNvCxnSpPr/>
          <p:nvPr/>
        </p:nvCxnSpPr>
        <p:spPr>
          <a:xfrm>
            <a:off x="10112867" y="3355290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36EBC171-6EEF-452F-8210-DB5AD0AFB18F}"/>
              </a:ext>
            </a:extLst>
          </p:cNvPr>
          <p:cNvSpPr txBox="1"/>
          <p:nvPr/>
        </p:nvSpPr>
        <p:spPr>
          <a:xfrm>
            <a:off x="10208188" y="3239891"/>
            <a:ext cx="803665" cy="230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FF2394DF-8750-F1AD-2EC7-D5AA7EDC4EEE}"/>
              </a:ext>
            </a:extLst>
          </p:cNvPr>
          <p:cNvCxnSpPr>
            <a:cxnSpLocks/>
          </p:cNvCxnSpPr>
          <p:nvPr/>
        </p:nvCxnSpPr>
        <p:spPr>
          <a:xfrm>
            <a:off x="6602588" y="3160603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2E859213-A93B-6EF1-84E9-9A429B975F90}"/>
              </a:ext>
            </a:extLst>
          </p:cNvPr>
          <p:cNvSpPr txBox="1"/>
          <p:nvPr/>
        </p:nvSpPr>
        <p:spPr>
          <a:xfrm>
            <a:off x="5828943" y="3043519"/>
            <a:ext cx="803665" cy="230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kD</a:t>
            </a: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76613953-7AE1-670B-96D2-1A90594FBAEF}"/>
              </a:ext>
            </a:extLst>
          </p:cNvPr>
          <p:cNvCxnSpPr>
            <a:cxnSpLocks/>
          </p:cNvCxnSpPr>
          <p:nvPr/>
        </p:nvCxnSpPr>
        <p:spPr>
          <a:xfrm>
            <a:off x="6602588" y="3337640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590B4C65-FF92-84DC-313C-A5914C140992}"/>
              </a:ext>
            </a:extLst>
          </p:cNvPr>
          <p:cNvSpPr txBox="1"/>
          <p:nvPr/>
        </p:nvSpPr>
        <p:spPr>
          <a:xfrm>
            <a:off x="5828943" y="3220556"/>
            <a:ext cx="803665" cy="230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940681CF-FA80-D39C-67F4-F9ABF35317D9}"/>
              </a:ext>
            </a:extLst>
          </p:cNvPr>
          <p:cNvCxnSpPr>
            <a:cxnSpLocks/>
          </p:cNvCxnSpPr>
          <p:nvPr/>
        </p:nvCxnSpPr>
        <p:spPr>
          <a:xfrm>
            <a:off x="6602588" y="5126757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33016BF0-9830-CA24-FA12-4E9A1B9F1B24}"/>
              </a:ext>
            </a:extLst>
          </p:cNvPr>
          <p:cNvSpPr txBox="1"/>
          <p:nvPr/>
        </p:nvSpPr>
        <p:spPr>
          <a:xfrm>
            <a:off x="5828943" y="5009673"/>
            <a:ext cx="803665" cy="230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BC4CC7B5-656E-83FF-1348-3F4D2489E564}"/>
              </a:ext>
            </a:extLst>
          </p:cNvPr>
          <p:cNvCxnSpPr>
            <a:cxnSpLocks/>
          </p:cNvCxnSpPr>
          <p:nvPr/>
        </p:nvCxnSpPr>
        <p:spPr>
          <a:xfrm>
            <a:off x="7129394" y="901966"/>
            <a:ext cx="7005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7F872B02-43A4-2520-1496-63CCB80907EE}"/>
              </a:ext>
            </a:extLst>
          </p:cNvPr>
          <p:cNvSpPr txBox="1"/>
          <p:nvPr/>
        </p:nvSpPr>
        <p:spPr>
          <a:xfrm>
            <a:off x="6987503" y="652615"/>
            <a:ext cx="98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F liver cells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A8731E5A-DB61-BCFB-5815-E438BE6CDF03}"/>
              </a:ext>
            </a:extLst>
          </p:cNvPr>
          <p:cNvSpPr txBox="1"/>
          <p:nvPr/>
        </p:nvSpPr>
        <p:spPr>
          <a:xfrm>
            <a:off x="7014440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F267AE18-08C3-0A6D-0CE2-24A3059B1921}"/>
              </a:ext>
            </a:extLst>
          </p:cNvPr>
          <p:cNvSpPr txBox="1"/>
          <p:nvPr/>
        </p:nvSpPr>
        <p:spPr>
          <a:xfrm>
            <a:off x="7228304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F1915329-10A7-ED0D-F733-44FC212DB395}"/>
              </a:ext>
            </a:extLst>
          </p:cNvPr>
          <p:cNvSpPr txBox="1"/>
          <p:nvPr/>
        </p:nvSpPr>
        <p:spPr>
          <a:xfrm>
            <a:off x="7442644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A601E959-574B-ADAA-73CB-97EDC3EE8CCC}"/>
              </a:ext>
            </a:extLst>
          </p:cNvPr>
          <p:cNvSpPr txBox="1"/>
          <p:nvPr/>
        </p:nvSpPr>
        <p:spPr>
          <a:xfrm>
            <a:off x="7650623" y="95009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A1C9900-4657-30F8-8EDC-4D456D44D205}"/>
              </a:ext>
            </a:extLst>
          </p:cNvPr>
          <p:cNvSpPr txBox="1"/>
          <p:nvPr/>
        </p:nvSpPr>
        <p:spPr>
          <a:xfrm rot="18953798">
            <a:off x="9315421" y="548528"/>
            <a:ext cx="98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F liver cells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75C5B736-FABD-A634-4959-990D3442207F}"/>
              </a:ext>
            </a:extLst>
          </p:cNvPr>
          <p:cNvSpPr txBox="1"/>
          <p:nvPr/>
        </p:nvSpPr>
        <p:spPr>
          <a:xfrm>
            <a:off x="9441725" y="949807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129F1B5B-A4C4-132A-4031-DF7279594E68}"/>
              </a:ext>
            </a:extLst>
          </p:cNvPr>
          <p:cNvCxnSpPr>
            <a:cxnSpLocks/>
          </p:cNvCxnSpPr>
          <p:nvPr/>
        </p:nvCxnSpPr>
        <p:spPr>
          <a:xfrm>
            <a:off x="7953466" y="901421"/>
            <a:ext cx="7005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2ED2636C-8498-529D-8E92-1C9FE61F84FF}"/>
              </a:ext>
            </a:extLst>
          </p:cNvPr>
          <p:cNvSpPr txBox="1"/>
          <p:nvPr/>
        </p:nvSpPr>
        <p:spPr>
          <a:xfrm>
            <a:off x="7811575" y="652070"/>
            <a:ext cx="98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 liver cells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204DF35C-A984-DA08-C027-637235933440}"/>
              </a:ext>
            </a:extLst>
          </p:cNvPr>
          <p:cNvSpPr txBox="1"/>
          <p:nvPr/>
        </p:nvSpPr>
        <p:spPr>
          <a:xfrm>
            <a:off x="7838512" y="94955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81B4C14-1487-929F-4949-680B43315BE1}"/>
              </a:ext>
            </a:extLst>
          </p:cNvPr>
          <p:cNvSpPr txBox="1"/>
          <p:nvPr/>
        </p:nvSpPr>
        <p:spPr>
          <a:xfrm>
            <a:off x="8052376" y="94955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F1498955-6130-F1E5-DFF4-A743320EB16B}"/>
              </a:ext>
            </a:extLst>
          </p:cNvPr>
          <p:cNvSpPr txBox="1"/>
          <p:nvPr/>
        </p:nvSpPr>
        <p:spPr>
          <a:xfrm>
            <a:off x="8245452" y="94955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DB50D06-85EC-2ECE-728F-12059F2BBD4B}"/>
              </a:ext>
            </a:extLst>
          </p:cNvPr>
          <p:cNvSpPr txBox="1"/>
          <p:nvPr/>
        </p:nvSpPr>
        <p:spPr>
          <a:xfrm>
            <a:off x="8446343" y="94955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53E2FD3A-EAFE-51C6-D995-E550482DFF17}"/>
              </a:ext>
            </a:extLst>
          </p:cNvPr>
          <p:cNvCxnSpPr>
            <a:cxnSpLocks/>
          </p:cNvCxnSpPr>
          <p:nvPr/>
        </p:nvCxnSpPr>
        <p:spPr>
          <a:xfrm>
            <a:off x="8756240" y="901421"/>
            <a:ext cx="7005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F6175490-72F2-0E08-5DD5-57BEC155091D}"/>
              </a:ext>
            </a:extLst>
          </p:cNvPr>
          <p:cNvSpPr txBox="1"/>
          <p:nvPr/>
        </p:nvSpPr>
        <p:spPr>
          <a:xfrm>
            <a:off x="8635613" y="652070"/>
            <a:ext cx="987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 liver cells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BCA7114D-DCEF-DB06-F9CF-F50CD0FFAFD0}"/>
              </a:ext>
            </a:extLst>
          </p:cNvPr>
          <p:cNvSpPr txBox="1"/>
          <p:nvPr/>
        </p:nvSpPr>
        <p:spPr>
          <a:xfrm>
            <a:off x="8641286" y="94955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AF7B2E9-1823-12F8-31C9-CA0C679AA971}"/>
              </a:ext>
            </a:extLst>
          </p:cNvPr>
          <p:cNvSpPr txBox="1"/>
          <p:nvPr/>
        </p:nvSpPr>
        <p:spPr>
          <a:xfrm>
            <a:off x="8855150" y="94955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h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E1C4563A-D5A6-3BF5-73FC-580065CED20E}"/>
              </a:ext>
            </a:extLst>
          </p:cNvPr>
          <p:cNvSpPr txBox="1"/>
          <p:nvPr/>
        </p:nvSpPr>
        <p:spPr>
          <a:xfrm>
            <a:off x="9041138" y="94955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h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06F819E5-963D-3850-F122-F6D2775F10A6}"/>
              </a:ext>
            </a:extLst>
          </p:cNvPr>
          <p:cNvSpPr txBox="1"/>
          <p:nvPr/>
        </p:nvSpPr>
        <p:spPr>
          <a:xfrm>
            <a:off x="9249117" y="949552"/>
            <a:ext cx="387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h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DB3C0B55-8C5D-58ED-9D03-BC25FC21E109}"/>
              </a:ext>
            </a:extLst>
          </p:cNvPr>
          <p:cNvSpPr txBox="1"/>
          <p:nvPr/>
        </p:nvSpPr>
        <p:spPr>
          <a:xfrm>
            <a:off x="8071266" y="162996"/>
            <a:ext cx="8036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el #2</a:t>
            </a:r>
          </a:p>
        </p:txBody>
      </p: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7DD6C775-A711-B890-6B33-689FE0787899}"/>
              </a:ext>
            </a:extLst>
          </p:cNvPr>
          <p:cNvCxnSpPr>
            <a:cxnSpLocks/>
          </p:cNvCxnSpPr>
          <p:nvPr/>
        </p:nvCxnSpPr>
        <p:spPr>
          <a:xfrm>
            <a:off x="10112867" y="5145654"/>
            <a:ext cx="22691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525E2B6C-8A52-8DD8-77FC-2B11684E197E}"/>
              </a:ext>
            </a:extLst>
          </p:cNvPr>
          <p:cNvSpPr txBox="1"/>
          <p:nvPr/>
        </p:nvSpPr>
        <p:spPr>
          <a:xfrm>
            <a:off x="10208188" y="5030244"/>
            <a:ext cx="803665" cy="2308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1258596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68</Words>
  <Application>Microsoft Macintosh PowerPoint</Application>
  <PresentationFormat>Widescreen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ia, Fanning</dc:creator>
  <cp:lastModifiedBy>Xia, Fanning</cp:lastModifiedBy>
  <cp:revision>1</cp:revision>
  <dcterms:created xsi:type="dcterms:W3CDTF">2025-09-18T14:11:33Z</dcterms:created>
  <dcterms:modified xsi:type="dcterms:W3CDTF">2025-09-18T14:25:18Z</dcterms:modified>
</cp:coreProperties>
</file>